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B8F90-B194-4670-AAEF-1784EF79DE4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23CE6-9FC7-49D9-98CD-E1A8F3DEE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807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B8F90-B194-4670-AAEF-1784EF79DE4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23CE6-9FC7-49D9-98CD-E1A8F3DEE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0569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B8F90-B194-4670-AAEF-1784EF79DE4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23CE6-9FC7-49D9-98CD-E1A8F3DEE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163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B8F90-B194-4670-AAEF-1784EF79DE4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23CE6-9FC7-49D9-98CD-E1A8F3DEE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732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B8F90-B194-4670-AAEF-1784EF79DE4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23CE6-9FC7-49D9-98CD-E1A8F3DEE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445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B8F90-B194-4670-AAEF-1784EF79DE4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23CE6-9FC7-49D9-98CD-E1A8F3DEE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202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B8F90-B194-4670-AAEF-1784EF79DE4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23CE6-9FC7-49D9-98CD-E1A8F3DEE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287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B8F90-B194-4670-AAEF-1784EF79DE4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23CE6-9FC7-49D9-98CD-E1A8F3DEE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593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B8F90-B194-4670-AAEF-1784EF79DE4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23CE6-9FC7-49D9-98CD-E1A8F3DEE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5677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B8F90-B194-4670-AAEF-1784EF79DE4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23CE6-9FC7-49D9-98CD-E1A8F3DEE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7209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B8F90-B194-4670-AAEF-1784EF79DE4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23CE6-9FC7-49D9-98CD-E1A8F3DEE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295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8B8F90-B194-4670-AAEF-1784EF79DE4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C23CE6-9FC7-49D9-98CD-E1A8F3DEE5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593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3711" y="-206710"/>
            <a:ext cx="2342062" cy="1498920"/>
          </a:xfrm>
          <a:prstGeom prst="rect">
            <a:avLst/>
          </a:prstGeom>
        </p:spPr>
      </p:pic>
      <p:sp>
        <p:nvSpPr>
          <p:cNvPr id="7" name="Down Arrow 6"/>
          <p:cNvSpPr/>
          <p:nvPr/>
        </p:nvSpPr>
        <p:spPr>
          <a:xfrm>
            <a:off x="5225140" y="1134870"/>
            <a:ext cx="446314" cy="62298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ounded Rectangle 7"/>
          <p:cNvSpPr/>
          <p:nvPr/>
        </p:nvSpPr>
        <p:spPr>
          <a:xfrm>
            <a:off x="4284344" y="1770357"/>
            <a:ext cx="2325733" cy="550863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/>
              <a:t>Hypersaline water</a:t>
            </a:r>
          </a:p>
          <a:p>
            <a:pPr algn="ctr"/>
            <a:r>
              <a:rPr lang="en-US" dirty="0" smtClean="0"/>
              <a:t>(50 g/L)</a:t>
            </a:r>
            <a:endParaRPr lang="en-US" dirty="0"/>
          </a:p>
        </p:txBody>
      </p:sp>
      <p:sp>
        <p:nvSpPr>
          <p:cNvPr id="9" name="Down Arrow 8"/>
          <p:cNvSpPr/>
          <p:nvPr/>
        </p:nvSpPr>
        <p:spPr>
          <a:xfrm>
            <a:off x="5225140" y="2365919"/>
            <a:ext cx="446314" cy="517819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ounded Rectangle 9"/>
          <p:cNvSpPr/>
          <p:nvPr/>
        </p:nvSpPr>
        <p:spPr>
          <a:xfrm>
            <a:off x="1524000" y="2969214"/>
            <a:ext cx="8252456" cy="542589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th ↓, antioxidant capacity ↓, Immune related genes expression ↓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Down Arrow 14"/>
          <p:cNvSpPr/>
          <p:nvPr/>
        </p:nvSpPr>
        <p:spPr>
          <a:xfrm>
            <a:off x="5225140" y="3551132"/>
            <a:ext cx="446314" cy="517819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9349" y="4075661"/>
            <a:ext cx="1553654" cy="1090366"/>
          </a:xfrm>
          <a:prstGeom prst="rect">
            <a:avLst/>
          </a:prstGeom>
        </p:spPr>
      </p:pic>
      <p:sp>
        <p:nvSpPr>
          <p:cNvPr id="18" name="Rounded Rectangle 17"/>
          <p:cNvSpPr/>
          <p:nvPr/>
        </p:nvSpPr>
        <p:spPr>
          <a:xfrm>
            <a:off x="2430558" y="5174811"/>
            <a:ext cx="1645917" cy="267789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sh oil (6%)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Cross 18"/>
          <p:cNvSpPr/>
          <p:nvPr/>
        </p:nvSpPr>
        <p:spPr>
          <a:xfrm>
            <a:off x="4178260" y="4523319"/>
            <a:ext cx="345623" cy="333107"/>
          </a:xfrm>
          <a:prstGeom prst="plus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17931" y="4088081"/>
            <a:ext cx="1337633" cy="1114063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1527" y="4105644"/>
            <a:ext cx="430785" cy="482551"/>
          </a:xfrm>
          <a:prstGeom prst="rect">
            <a:avLst/>
          </a:prstGeom>
        </p:spPr>
      </p:pic>
      <p:sp>
        <p:nvSpPr>
          <p:cNvPr id="22" name="Rounded Rectangle 21"/>
          <p:cNvSpPr/>
          <p:nvPr/>
        </p:nvSpPr>
        <p:spPr>
          <a:xfrm>
            <a:off x="4495900" y="5202144"/>
            <a:ext cx="1645917" cy="267789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NPs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0.4 mg/kg)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Down Arrow 22"/>
          <p:cNvSpPr/>
          <p:nvPr/>
        </p:nvSpPr>
        <p:spPr>
          <a:xfrm>
            <a:off x="5123090" y="5486264"/>
            <a:ext cx="446314" cy="517819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6297" y="3852461"/>
            <a:ext cx="1674303" cy="1674303"/>
          </a:xfrm>
          <a:prstGeom prst="rect">
            <a:avLst/>
          </a:prstGeom>
        </p:spPr>
      </p:pic>
      <p:sp>
        <p:nvSpPr>
          <p:cNvPr id="27" name="Notched Right Arrow 26"/>
          <p:cNvSpPr/>
          <p:nvPr/>
        </p:nvSpPr>
        <p:spPr>
          <a:xfrm>
            <a:off x="6096000" y="4522800"/>
            <a:ext cx="644435" cy="333626"/>
          </a:xfrm>
          <a:prstGeom prst="notched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ounded Rectangle 28"/>
          <p:cNvSpPr/>
          <p:nvPr/>
        </p:nvSpPr>
        <p:spPr>
          <a:xfrm>
            <a:off x="261257" y="6122906"/>
            <a:ext cx="11260183" cy="542589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th ↑, antioxidant capacity (i.e. GSH, CAT, SOD and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Px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↑,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pid peroxidation (MDA) ↓, immune related genes expression (i.e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z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c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pen3 and </a:t>
            </a:r>
            <a:r>
              <a:rPr lang="en-US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po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↑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26421" y="163907"/>
            <a:ext cx="3500846" cy="24632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US" smtClean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: Supplementing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iet with 6% fish oil and 0.4 mg/kg selenium nanoparticles improved growth, antioxidant capacity and immune responses in </a:t>
            </a:r>
            <a:r>
              <a:rPr lang="en-US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enaeus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vannamei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juveniles reared in hypersaline water (50 g/L)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37974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</TotalTime>
  <Words>104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Microsoft account</cp:lastModifiedBy>
  <cp:revision>9</cp:revision>
  <dcterms:created xsi:type="dcterms:W3CDTF">2025-06-10T06:36:30Z</dcterms:created>
  <dcterms:modified xsi:type="dcterms:W3CDTF">2025-08-13T11:18:31Z</dcterms:modified>
</cp:coreProperties>
</file>